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5"/>
  </p:notesMasterIdLst>
  <p:sldIdLst>
    <p:sldId id="279" r:id="rId2"/>
    <p:sldId id="280" r:id="rId3"/>
    <p:sldId id="282" r:id="rId4"/>
    <p:sldId id="304" r:id="rId5"/>
    <p:sldId id="285" r:id="rId6"/>
    <p:sldId id="284" r:id="rId7"/>
    <p:sldId id="288" r:id="rId8"/>
    <p:sldId id="287" r:id="rId9"/>
    <p:sldId id="289" r:id="rId10"/>
    <p:sldId id="290" r:id="rId11"/>
    <p:sldId id="303" r:id="rId12"/>
    <p:sldId id="306" r:id="rId13"/>
    <p:sldId id="291" r:id="rId14"/>
    <p:sldId id="292" r:id="rId15"/>
    <p:sldId id="293" r:id="rId16"/>
    <p:sldId id="300" r:id="rId17"/>
    <p:sldId id="294" r:id="rId18"/>
    <p:sldId id="301" r:id="rId19"/>
    <p:sldId id="295" r:id="rId20"/>
    <p:sldId id="296" r:id="rId21"/>
    <p:sldId id="298" r:id="rId22"/>
    <p:sldId id="297" r:id="rId23"/>
    <p:sldId id="299" r:id="rId2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uario" initials="U" lastIdx="7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Estilo medio 2 - Énfasis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49" autoAdjust="0"/>
    <p:restoredTop sz="86357" autoAdjust="0"/>
  </p:normalViewPr>
  <p:slideViewPr>
    <p:cSldViewPr snapToGrid="0">
      <p:cViewPr varScale="1">
        <p:scale>
          <a:sx n="62" d="100"/>
          <a:sy n="62" d="100"/>
        </p:scale>
        <p:origin x="914" y="50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144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5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commentAuthors" Target="commentAuthor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1AD59A-CC11-4F32-AA51-6C1943E98222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579676-4055-4815-A99C-C75CD754E85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5285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25814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1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797148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1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3681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1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61745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20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254734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6579676-4055-4815-A99C-C75CD754E855}" type="slidenum">
              <a:rPr lang="es-ES" smtClean="0"/>
              <a:t>2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5099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8566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3136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540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7267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9274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535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4056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9080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1719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8722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7328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31BD8-363A-4EE9-AA06-361B8B0FD31B}" type="datetimeFigureOut">
              <a:rPr lang="es-ES" smtClean="0"/>
              <a:t>12/12/20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C23B1-13BC-47F5-A658-514DC1658E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4202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13" y="1639314"/>
            <a:ext cx="6701388" cy="5026041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3005129" y="1454648"/>
            <a:ext cx="1596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Leaf</a:t>
            </a:r>
            <a:r>
              <a:rPr lang="es-ES" i="1" dirty="0" smtClean="0"/>
              <a:t> </a:t>
            </a:r>
            <a:r>
              <a:rPr lang="es-ES" i="1" dirty="0" err="1" smtClean="0"/>
              <a:t>incision</a:t>
            </a:r>
            <a:r>
              <a:rPr lang="es-ES" i="1" dirty="0" smtClean="0"/>
              <a:t>, Li</a:t>
            </a:r>
            <a:endParaRPr lang="es-ES" i="1" dirty="0"/>
          </a:p>
        </p:txBody>
      </p:sp>
      <p:sp>
        <p:nvSpPr>
          <p:cNvPr id="4" name="Rectángulo 3"/>
          <p:cNvSpPr/>
          <p:nvPr/>
        </p:nvSpPr>
        <p:spPr>
          <a:xfrm>
            <a:off x="0" y="-74882"/>
            <a:ext cx="1203267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Additional file 4. a) LOD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peaks of the QTLs identified in the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RIL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population for vine, flowering and fruit traits. Lines represent the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thresholds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p 0.01 and 0.05. Results of </a:t>
            </a:r>
            <a:r>
              <a:rPr lang="en-US" sz="1600" i="1" dirty="0" err="1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cim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 analysis with a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20 </a:t>
            </a:r>
            <a:r>
              <a:rPr lang="en-US" sz="1600" dirty="0" err="1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cM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windows are shown for each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trait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.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First box show QTL results with data from all the environments and the other three boxes show the QTL results for single environments Paip2014, Paip2015 and UPV2015.</a:t>
            </a:r>
          </a:p>
          <a:p>
            <a:pPr algn="just"/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b)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 Means and errors of the phenotype of alternative allelic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classes, homozygous Zucchini (AA) and homozygous Scallop (BB),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are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shown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for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each QTL, calculated with </a:t>
            </a:r>
            <a:r>
              <a:rPr lang="en-US" sz="1600" dirty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the full set of data and with the data form each environment separately.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c) Genetic correlations (r </a:t>
            </a:r>
            <a:r>
              <a:rPr lang="en-US" sz="1600" dirty="0" err="1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x,y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) between locations for each trait (*p&lt;0.05, **p&lt;0.01, ***p&lt;0.001, ns </a:t>
            </a:r>
            <a:r>
              <a:rPr lang="en-US" sz="1600" dirty="0" smtClean="0">
                <a:solidFill>
                  <a:srgbClr val="00000A"/>
                </a:solidFill>
                <a:latin typeface="Calibri" panose="020F0502020204030204" pitchFamily="34" charset="0"/>
                <a:ea typeface="Droid Sans Fallback"/>
                <a:cs typeface="Times New Roman" panose="02020603050405020304" pitchFamily="18" charset="0"/>
              </a:rPr>
              <a:t>non-significant)</a:t>
            </a:r>
            <a:endParaRPr lang="es-ES" sz="1600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9125" y="1269982"/>
            <a:ext cx="4667109" cy="4667109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081760" y="1454648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Li_10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33917" y="138238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7968754" y="138238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7968754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8873682"/>
              </p:ext>
            </p:extLst>
          </p:nvPr>
        </p:nvGraphicFramePr>
        <p:xfrm>
          <a:off x="7910865" y="575669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628681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2578785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520081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21911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637" y="714109"/>
            <a:ext cx="7623818" cy="5717863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466157" y="344777"/>
            <a:ext cx="3187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/>
              <a:t>R</a:t>
            </a:r>
            <a:r>
              <a:rPr lang="es-ES" i="1" dirty="0" err="1" smtClean="0"/>
              <a:t>ibbing</a:t>
            </a:r>
            <a:r>
              <a:rPr lang="es-ES" i="1" dirty="0" smtClean="0"/>
              <a:t>, </a:t>
            </a:r>
            <a:r>
              <a:rPr lang="es-ES" i="1" dirty="0" err="1" smtClean="0"/>
              <a:t>IFRib</a:t>
            </a:r>
            <a:r>
              <a:rPr lang="es-ES" i="1" dirty="0" smtClean="0"/>
              <a:t>     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28207" y="437652"/>
            <a:ext cx="4109634" cy="4109634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556785" y="392010"/>
            <a:ext cx="2597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IFRib_3</a:t>
            </a:r>
            <a:endParaRPr lang="es-ES" i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303048" y="19501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8005102" y="16011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8042629" y="476160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9" name="Tab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5923071"/>
              </p:ext>
            </p:extLst>
          </p:nvPr>
        </p:nvGraphicFramePr>
        <p:xfrm>
          <a:off x="8559594" y="5385807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6397965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810294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423639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475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737" y="830712"/>
            <a:ext cx="7496056" cy="5622042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755619" y="574499"/>
            <a:ext cx="2846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Ribbing</a:t>
            </a:r>
            <a:r>
              <a:rPr lang="es-ES" i="1" dirty="0" smtClean="0"/>
              <a:t>, </a:t>
            </a:r>
            <a:r>
              <a:rPr lang="es-ES" i="1" dirty="0" err="1" smtClean="0"/>
              <a:t>MFRib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9761" y="102069"/>
            <a:ext cx="2971800" cy="29718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9761" y="2853799"/>
            <a:ext cx="2977726" cy="2977726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383379" y="70132"/>
            <a:ext cx="1184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MFRib_12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472839" y="2851955"/>
            <a:ext cx="1184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MFRib_21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224739" y="13115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7926793" y="9625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7968754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1987122"/>
              </p:ext>
            </p:extLst>
          </p:nvPr>
        </p:nvGraphicFramePr>
        <p:xfrm>
          <a:off x="8580048" y="5761318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813860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567776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4755085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86145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875" y="766972"/>
            <a:ext cx="8024388" cy="6018291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447419" y="500615"/>
            <a:ext cx="33279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Peduncle</a:t>
            </a:r>
            <a:r>
              <a:rPr lang="es-ES" i="1" dirty="0" smtClean="0"/>
              <a:t> </a:t>
            </a:r>
            <a:r>
              <a:rPr lang="es-ES" i="1" dirty="0" err="1" smtClean="0"/>
              <a:t>Length</a:t>
            </a:r>
            <a:r>
              <a:rPr lang="es-ES" i="1" dirty="0" smtClean="0"/>
              <a:t>, </a:t>
            </a:r>
            <a:r>
              <a:rPr lang="es-ES" i="1" dirty="0" err="1" smtClean="0"/>
              <a:t>IPeLe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1111" y="178029"/>
            <a:ext cx="2818485" cy="2818485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1110" y="2882834"/>
            <a:ext cx="2797025" cy="2797025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697913" y="178029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PeLe_10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784410" y="2811848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PeLe_16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492733" y="16151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8515043" y="12850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2203989"/>
              </p:ext>
            </p:extLst>
          </p:nvPr>
        </p:nvGraphicFramePr>
        <p:xfrm>
          <a:off x="8655714" y="5750845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681670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377775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10162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  <p:sp>
        <p:nvSpPr>
          <p:cNvPr id="12" name="CuadroTexto 11"/>
          <p:cNvSpPr txBox="1"/>
          <p:nvPr/>
        </p:nvSpPr>
        <p:spPr>
          <a:xfrm>
            <a:off x="8463155" y="534602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00336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860" y="766295"/>
            <a:ext cx="7910945" cy="5933209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745626" y="396963"/>
            <a:ext cx="321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/>
              <a:t>M</a:t>
            </a:r>
            <a:r>
              <a:rPr lang="es-ES" i="1" dirty="0" err="1" smtClean="0"/>
              <a:t>ature</a:t>
            </a:r>
            <a:r>
              <a:rPr lang="es-ES" i="1" dirty="0" smtClean="0"/>
              <a:t> </a:t>
            </a:r>
            <a:r>
              <a:rPr lang="es-ES" i="1" dirty="0" err="1" smtClean="0"/>
              <a:t>Peduncle</a:t>
            </a:r>
            <a:r>
              <a:rPr lang="es-ES" i="1" dirty="0" smtClean="0"/>
              <a:t> </a:t>
            </a:r>
            <a:r>
              <a:rPr lang="es-ES" i="1" dirty="0" err="1" smtClean="0"/>
              <a:t>lenght</a:t>
            </a:r>
            <a:r>
              <a:rPr lang="es-ES" i="1" dirty="0" smtClean="0"/>
              <a:t>, </a:t>
            </a:r>
            <a:r>
              <a:rPr lang="es-ES" i="1" dirty="0" err="1"/>
              <a:t>M</a:t>
            </a:r>
            <a:r>
              <a:rPr lang="es-ES" i="1" dirty="0" err="1" smtClean="0"/>
              <a:t>PeLe</a:t>
            </a:r>
            <a:r>
              <a:rPr lang="es-ES" i="1" dirty="0" smtClean="0"/>
              <a:t> 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9654" y="1406236"/>
            <a:ext cx="3751118" cy="3751118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608258" y="1406236"/>
            <a:ext cx="1173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PeLe_14</a:t>
            </a:r>
            <a:endParaRPr lang="es-ES" i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323978" y="247202"/>
            <a:ext cx="281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8329576" y="212297"/>
            <a:ext cx="273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8334542" y="537688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9" name="Tab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8268461"/>
              </p:ext>
            </p:extLst>
          </p:nvPr>
        </p:nvGraphicFramePr>
        <p:xfrm>
          <a:off x="8658449" y="574621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9192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8619385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33289747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11953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614" y="811044"/>
            <a:ext cx="7879218" cy="5909414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860093" y="441712"/>
            <a:ext cx="3828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</a:t>
            </a:r>
            <a:r>
              <a:rPr lang="es-ES" i="1" dirty="0" err="1" smtClean="0"/>
              <a:t>Lightness</a:t>
            </a:r>
            <a:r>
              <a:rPr lang="es-ES" i="1" dirty="0" smtClean="0"/>
              <a:t>, </a:t>
            </a:r>
            <a:r>
              <a:rPr lang="es-ES" i="1" dirty="0" err="1" smtClean="0"/>
              <a:t>ILR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546" y="3664272"/>
            <a:ext cx="1855599" cy="1855599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4728" y="80815"/>
            <a:ext cx="1846417" cy="1846417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944474" y="3555873"/>
            <a:ext cx="1239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ILRCo_1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944474" y="-21701"/>
            <a:ext cx="934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LRCo_4</a:t>
            </a:r>
            <a:endParaRPr lang="es-ES" i="1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5546" y="1820408"/>
            <a:ext cx="1855599" cy="1855599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9876612" y="1702033"/>
            <a:ext cx="120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ILRCo_10</a:t>
            </a:r>
            <a:endParaRPr lang="es-ES" i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290946" y="19787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8672770" y="25704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graphicFrame>
        <p:nvGraphicFramePr>
          <p:cNvPr id="14" name="Tab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7357181"/>
              </p:ext>
            </p:extLst>
          </p:nvPr>
        </p:nvGraphicFramePr>
        <p:xfrm>
          <a:off x="8672770" y="5662245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925571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5236591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517095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  <p:sp>
        <p:nvSpPr>
          <p:cNvPr id="17" name="CuadroTexto 16"/>
          <p:cNvSpPr txBox="1"/>
          <p:nvPr/>
        </p:nvSpPr>
        <p:spPr>
          <a:xfrm>
            <a:off x="8607845" y="515053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42866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105" y="987136"/>
            <a:ext cx="7565804" cy="5674353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447886" y="486695"/>
            <a:ext cx="4119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</a:t>
            </a:r>
            <a:r>
              <a:rPr lang="es-ES" i="1" dirty="0" err="1" smtClean="0"/>
              <a:t>Lightness</a:t>
            </a:r>
            <a:r>
              <a:rPr lang="es-ES" i="1" dirty="0" smtClean="0"/>
              <a:t>, </a:t>
            </a:r>
            <a:r>
              <a:rPr lang="es-ES" i="1" dirty="0" err="1" smtClean="0"/>
              <a:t>MLR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6654" y="1930580"/>
            <a:ext cx="1778891" cy="1778891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486858" y="1786571"/>
            <a:ext cx="1080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LRCo_1</a:t>
            </a:r>
            <a:endParaRPr lang="es-ES" i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06654" y="127244"/>
            <a:ext cx="1719783" cy="1719783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452065" y="-42808"/>
            <a:ext cx="1108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MLRCo_4</a:t>
            </a:r>
            <a:endParaRPr lang="es-ES" i="1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6963" y="3760325"/>
            <a:ext cx="1728582" cy="1728582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9556785" y="3557071"/>
            <a:ext cx="1080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LRCo_2</a:t>
            </a:r>
            <a:endParaRPr lang="es-ES" i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539105" y="2058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8241159" y="17092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8241159" y="511957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8538170"/>
              </p:ext>
            </p:extLst>
          </p:nvPr>
        </p:nvGraphicFramePr>
        <p:xfrm>
          <a:off x="8555669" y="5585626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54026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6744861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407228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541906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00" y="573024"/>
            <a:ext cx="8071104" cy="6053328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248797" y="203692"/>
            <a:ext cx="4034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 a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IaR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3541" y="2629651"/>
            <a:ext cx="2871492" cy="2871492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4926" y="19026"/>
            <a:ext cx="2940107" cy="2940107"/>
          </a:xfrm>
          <a:prstGeom prst="rect">
            <a:avLst/>
          </a:prstGeom>
        </p:spPr>
      </p:pic>
      <p:sp>
        <p:nvSpPr>
          <p:cNvPr id="8" name="CuadroTexto 7"/>
          <p:cNvSpPr txBox="1"/>
          <p:nvPr/>
        </p:nvSpPr>
        <p:spPr>
          <a:xfrm>
            <a:off x="9928707" y="2669501"/>
            <a:ext cx="9536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aRCo_3</a:t>
            </a:r>
            <a:endParaRPr lang="es-ES" i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9811688" y="19026"/>
            <a:ext cx="1070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aRCo_10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230400" y="1972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8489031" y="9950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8756323"/>
              </p:ext>
            </p:extLst>
          </p:nvPr>
        </p:nvGraphicFramePr>
        <p:xfrm>
          <a:off x="8593366" y="5614591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841613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5299548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507340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  <p:sp>
        <p:nvSpPr>
          <p:cNvPr id="14" name="CuadroTexto 13"/>
          <p:cNvSpPr txBox="1"/>
          <p:nvPr/>
        </p:nvSpPr>
        <p:spPr>
          <a:xfrm>
            <a:off x="8428432" y="50356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69098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29" y="779004"/>
            <a:ext cx="7669306" cy="575198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213809" y="409672"/>
            <a:ext cx="3947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a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MaRCo</a:t>
            </a:r>
            <a:r>
              <a:rPr lang="es-ES" i="1" dirty="0" smtClean="0"/>
              <a:t> </a:t>
            </a:r>
            <a:endParaRPr lang="es-ES" i="1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9590" y="1277006"/>
            <a:ext cx="3925690" cy="3925690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744845" y="1092340"/>
            <a:ext cx="1230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MaRCo_4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20281" y="24245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8179590" y="22500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8134046" y="521482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5651046"/>
              </p:ext>
            </p:extLst>
          </p:nvPr>
        </p:nvGraphicFramePr>
        <p:xfrm>
          <a:off x="8627557" y="5579249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814373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468647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838508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63541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318" y="648808"/>
            <a:ext cx="8132618" cy="6099464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031343" y="312601"/>
            <a:ext cx="4001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b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IbRCo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835923" y="1878551"/>
            <a:ext cx="964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bRCo_3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9816889" y="-20656"/>
            <a:ext cx="964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bRCo_4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9816889" y="3796698"/>
            <a:ext cx="1081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bRCo_12</a:t>
            </a:r>
            <a:endParaRPr lang="es-ES" i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219318" y="19891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8455030" y="16401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6181" y="2185593"/>
            <a:ext cx="1692797" cy="1692797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6181" y="295311"/>
            <a:ext cx="1692797" cy="1692797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36016" y="4101239"/>
            <a:ext cx="1726626" cy="1726626"/>
          </a:xfrm>
          <a:prstGeom prst="rect">
            <a:avLst/>
          </a:prstGeom>
        </p:spPr>
      </p:pic>
      <p:graphicFrame>
        <p:nvGraphicFramePr>
          <p:cNvPr id="16" name="Tabla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9354106"/>
              </p:ext>
            </p:extLst>
          </p:nvPr>
        </p:nvGraphicFramePr>
        <p:xfrm>
          <a:off x="8612285" y="5796537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034099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331725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8903925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  <p:sp>
        <p:nvSpPr>
          <p:cNvPr id="19" name="CuadroTexto 18"/>
          <p:cNvSpPr txBox="1"/>
          <p:nvPr/>
        </p:nvSpPr>
        <p:spPr>
          <a:xfrm>
            <a:off x="8521501" y="517043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77415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329" y="698321"/>
            <a:ext cx="8086165" cy="6064624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191537" y="328989"/>
            <a:ext cx="3947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Rind</a:t>
            </a:r>
            <a:r>
              <a:rPr lang="es-ES" i="1" dirty="0" smtClean="0"/>
              <a:t> color, b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MbRCo</a:t>
            </a:r>
            <a:r>
              <a:rPr lang="es-ES" i="1" dirty="0" smtClean="0"/>
              <a:t> 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6700" y="208860"/>
            <a:ext cx="2762004" cy="2762004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771444" y="89807"/>
            <a:ext cx="1104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bRCo_4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667022" y="2739848"/>
            <a:ext cx="1221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bRCo_19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287229" y="1792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8395342" y="17922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41013" y="3039003"/>
            <a:ext cx="2717691" cy="2717691"/>
          </a:xfrm>
          <a:prstGeom prst="rect">
            <a:avLst/>
          </a:prstGeom>
        </p:spPr>
      </p:pic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988730"/>
              </p:ext>
            </p:extLst>
          </p:nvPr>
        </p:nvGraphicFramePr>
        <p:xfrm>
          <a:off x="8580048" y="5729052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6202738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71034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86584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  <p:sp>
        <p:nvSpPr>
          <p:cNvPr id="14" name="CuadroTexto 13"/>
          <p:cNvSpPr txBox="1"/>
          <p:nvPr/>
        </p:nvSpPr>
        <p:spPr>
          <a:xfrm>
            <a:off x="8404910" y="52026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317753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2798391" y="706583"/>
            <a:ext cx="1431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err="1" smtClean="0"/>
              <a:t>Silver</a:t>
            </a:r>
            <a:r>
              <a:rPr lang="es-ES" i="1" dirty="0" smtClean="0"/>
              <a:t> </a:t>
            </a:r>
            <a:r>
              <a:rPr lang="es-ES" i="1" dirty="0" err="1" smtClean="0"/>
              <a:t>leaf</a:t>
            </a:r>
            <a:r>
              <a:rPr lang="es-ES" i="1" dirty="0" smtClean="0"/>
              <a:t>, </a:t>
            </a:r>
            <a:r>
              <a:rPr lang="es-ES" i="1" dirty="0" err="1" smtClean="0"/>
              <a:t>Sl</a:t>
            </a:r>
            <a:endParaRPr lang="es-ES" i="1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91" y="1075915"/>
            <a:ext cx="6670358" cy="5002768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4092" y="806672"/>
            <a:ext cx="5272011" cy="5272011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372600" y="706583"/>
            <a:ext cx="692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Sl_12</a:t>
            </a:r>
            <a:endParaRPr lang="es-ES" i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317500" y="4198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7991091" y="43734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7999107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9" name="Tab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4178038"/>
              </p:ext>
            </p:extLst>
          </p:nvPr>
        </p:nvGraphicFramePr>
        <p:xfrm>
          <a:off x="7910865" y="575669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2285850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7482580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82925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5086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336" y="914130"/>
            <a:ext cx="7315200" cy="54864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168520" y="522188"/>
            <a:ext cx="4024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lesh</a:t>
            </a:r>
            <a:r>
              <a:rPr lang="es-ES" i="1" dirty="0" smtClean="0"/>
              <a:t> color, a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IaF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2657" y="218427"/>
            <a:ext cx="2828901" cy="2828901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3918" y="2786462"/>
            <a:ext cx="2811149" cy="2811149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556785" y="190618"/>
            <a:ext cx="1051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aFCo_10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9611581" y="2786462"/>
            <a:ext cx="1051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aFCo_13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300050" y="240371"/>
            <a:ext cx="281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8002104" y="205466"/>
            <a:ext cx="273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8037480" y="522827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1458267"/>
              </p:ext>
            </p:extLst>
          </p:nvPr>
        </p:nvGraphicFramePr>
        <p:xfrm>
          <a:off x="8436585" y="575669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579677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693512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85469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0583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96" y="895959"/>
            <a:ext cx="7522464" cy="5641848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544152" y="526627"/>
            <a:ext cx="3934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lesh</a:t>
            </a:r>
            <a:r>
              <a:rPr lang="es-ES" i="1" dirty="0" smtClean="0"/>
              <a:t> color, a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MaF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1220" y="1921803"/>
            <a:ext cx="1890256" cy="1890256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8876" y="3879288"/>
            <a:ext cx="1832600" cy="183260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8902" y="57170"/>
            <a:ext cx="1864633" cy="1864633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556785" y="1786283"/>
            <a:ext cx="1190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aFCo_10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9556785" y="3691925"/>
            <a:ext cx="1190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aFCo_13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9493141" y="-75274"/>
            <a:ext cx="1190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aFCo_19</a:t>
            </a:r>
            <a:endParaRPr lang="es-ES" i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282490" y="32896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8275248" y="29405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8277226" y="509697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5946007"/>
              </p:ext>
            </p:extLst>
          </p:nvPr>
        </p:nvGraphicFramePr>
        <p:xfrm>
          <a:off x="8563042" y="5675137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8319048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676831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3978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5020820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/>
          <p:cNvSpPr txBox="1"/>
          <p:nvPr/>
        </p:nvSpPr>
        <p:spPr>
          <a:xfrm>
            <a:off x="2468720" y="264650"/>
            <a:ext cx="40468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lesh</a:t>
            </a:r>
            <a:r>
              <a:rPr lang="es-ES" i="1" dirty="0" smtClean="0"/>
              <a:t> color, b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IbFCo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416" y="633982"/>
            <a:ext cx="7894875" cy="5921156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775627" y="855114"/>
            <a:ext cx="10626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bFCo_10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315982" y="11488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8389327" y="8984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2546" y="1224446"/>
            <a:ext cx="3748438" cy="3748438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8332546" y="505373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0" name="Tabl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2791763"/>
              </p:ext>
            </p:extLst>
          </p:nvPr>
        </p:nvGraphicFramePr>
        <p:xfrm>
          <a:off x="8661039" y="5603404"/>
          <a:ext cx="3291841" cy="94400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4667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7674113</a:t>
                      </a:r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4667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667875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4667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438971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177734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838" y="867641"/>
            <a:ext cx="7987145" cy="5990359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546187" y="498309"/>
            <a:ext cx="49102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lesh</a:t>
            </a:r>
            <a:r>
              <a:rPr lang="es-ES" i="1" dirty="0" smtClean="0"/>
              <a:t> color, b </a:t>
            </a:r>
            <a:r>
              <a:rPr lang="es-ES" i="1" dirty="0" err="1" smtClean="0"/>
              <a:t>parameter</a:t>
            </a:r>
            <a:r>
              <a:rPr lang="es-ES" i="1" dirty="0" smtClean="0"/>
              <a:t>, </a:t>
            </a:r>
            <a:r>
              <a:rPr lang="es-ES" i="1" dirty="0" err="1" smtClean="0"/>
              <a:t>MbFCo</a:t>
            </a:r>
            <a:endParaRPr lang="es-ES" i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9556785" y="1011501"/>
            <a:ext cx="1202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MbFCo_19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287202" y="33109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8405031" y="31364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2286" y="1431541"/>
            <a:ext cx="3316886" cy="3316886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8413047" y="49178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0" name="Tabl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0226021"/>
              </p:ext>
            </p:extLst>
          </p:nvPr>
        </p:nvGraphicFramePr>
        <p:xfrm>
          <a:off x="8684162" y="5572028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93280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591276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369378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018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316" y="901266"/>
            <a:ext cx="7049176" cy="5286882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94352" y="531934"/>
            <a:ext cx="81534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err="1" smtClean="0"/>
              <a:t>Days</a:t>
            </a:r>
            <a:r>
              <a:rPr lang="es-ES" i="1" dirty="0" smtClean="0"/>
              <a:t> </a:t>
            </a:r>
            <a:r>
              <a:rPr lang="es-ES" i="1" dirty="0" err="1" smtClean="0"/>
              <a:t>from</a:t>
            </a:r>
            <a:r>
              <a:rPr lang="es-ES" i="1" dirty="0" smtClean="0"/>
              <a:t> </a:t>
            </a:r>
            <a:r>
              <a:rPr lang="es-ES" i="1" dirty="0" err="1" smtClean="0"/>
              <a:t>transplanting</a:t>
            </a:r>
            <a:r>
              <a:rPr lang="es-ES" i="1" dirty="0" smtClean="0"/>
              <a:t> to </a:t>
            </a:r>
            <a:r>
              <a:rPr lang="es-ES" i="1" dirty="0" err="1" smtClean="0"/>
              <a:t>the</a:t>
            </a:r>
            <a:r>
              <a:rPr lang="es-ES" i="1" dirty="0" smtClean="0"/>
              <a:t> </a:t>
            </a:r>
            <a:r>
              <a:rPr lang="es-ES" i="1" dirty="0" err="1" smtClean="0"/>
              <a:t>development</a:t>
            </a:r>
            <a:r>
              <a:rPr lang="es-ES" i="1" dirty="0" smtClean="0"/>
              <a:t> of </a:t>
            </a:r>
            <a:r>
              <a:rPr lang="es-ES" i="1" dirty="0" err="1" smtClean="0"/>
              <a:t>the</a:t>
            </a:r>
            <a:r>
              <a:rPr lang="es-ES" i="1" dirty="0" smtClean="0"/>
              <a:t> </a:t>
            </a:r>
            <a:r>
              <a:rPr lang="es-ES" i="1" dirty="0" err="1" smtClean="0"/>
              <a:t>first</a:t>
            </a:r>
            <a:r>
              <a:rPr lang="es-ES" i="1" dirty="0" smtClean="0"/>
              <a:t> </a:t>
            </a:r>
            <a:r>
              <a:rPr lang="es-ES" i="1" dirty="0" err="1" smtClean="0"/>
              <a:t>female</a:t>
            </a:r>
            <a:r>
              <a:rPr lang="es-ES" i="1" dirty="0" smtClean="0"/>
              <a:t> </a:t>
            </a:r>
            <a:r>
              <a:rPr lang="es-ES" i="1" dirty="0" err="1" smtClean="0"/>
              <a:t>flower</a:t>
            </a:r>
            <a:r>
              <a:rPr lang="es-ES" i="1" dirty="0" smtClean="0"/>
              <a:t>, </a:t>
            </a:r>
            <a:r>
              <a:rPr lang="es-ES" i="1" dirty="0" err="1" smtClean="0"/>
              <a:t>DFeF</a:t>
            </a:r>
            <a:r>
              <a:rPr lang="es-ES" i="1" dirty="0" smtClean="0"/>
              <a:t> </a:t>
            </a:r>
            <a:endParaRPr lang="es-ES" i="1" dirty="0"/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00782" y="106862"/>
            <a:ext cx="3109593" cy="3109593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19657" y="2837253"/>
            <a:ext cx="3071841" cy="307184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474521" y="149391"/>
            <a:ext cx="995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DFeF_12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9586667" y="2889652"/>
            <a:ext cx="8833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DFeF_9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284218" y="11817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7986272" y="8327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7991666" y="54905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4" name="Tab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7195141"/>
              </p:ext>
            </p:extLst>
          </p:nvPr>
        </p:nvGraphicFramePr>
        <p:xfrm>
          <a:off x="8121154" y="5820267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28952726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28174793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36463202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8672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161" y="824695"/>
            <a:ext cx="7461894" cy="559642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158729" y="369332"/>
            <a:ext cx="2676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shape</a:t>
            </a:r>
            <a:r>
              <a:rPr lang="es-ES" i="1" dirty="0" smtClean="0"/>
              <a:t>, </a:t>
            </a:r>
            <a:r>
              <a:rPr lang="es-ES" i="1" dirty="0" err="1" smtClean="0"/>
              <a:t>IFSh</a:t>
            </a:r>
            <a:endParaRPr lang="es-ES" i="1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8427" y="28683"/>
            <a:ext cx="2892649" cy="2892649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8428" y="2830001"/>
            <a:ext cx="2892649" cy="2892649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508202" y="28683"/>
            <a:ext cx="804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FSh_3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9449693" y="2736666"/>
            <a:ext cx="921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FSh_12</a:t>
            </a:r>
            <a:endParaRPr lang="es-ES" i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321079" y="1335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8023133" y="9863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8031149" y="516566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4" name="Tab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0597849"/>
              </p:ext>
            </p:extLst>
          </p:nvPr>
        </p:nvGraphicFramePr>
        <p:xfrm>
          <a:off x="8264764" y="5617793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8447873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96175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132643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05448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493" y="746331"/>
            <a:ext cx="7651583" cy="5738688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309531" y="376999"/>
            <a:ext cx="2768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/>
              <a:t>L</a:t>
            </a:r>
            <a:r>
              <a:rPr lang="es-ES" i="1" dirty="0" err="1" smtClean="0"/>
              <a:t>enght</a:t>
            </a:r>
            <a:r>
              <a:rPr lang="es-ES" i="1" dirty="0" smtClean="0"/>
              <a:t>, </a:t>
            </a:r>
            <a:r>
              <a:rPr lang="es-ES" i="1" dirty="0" err="1" smtClean="0"/>
              <a:t>IFLe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7347" y="-40387"/>
            <a:ext cx="2033389" cy="2033389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929414" y="-80749"/>
            <a:ext cx="7938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FLe_3</a:t>
            </a:r>
            <a:endParaRPr lang="es-ES" i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7347" y="1833849"/>
            <a:ext cx="2081539" cy="2076863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9870905" y="1762922"/>
            <a:ext cx="9532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i="1" dirty="0" smtClean="0"/>
              <a:t>IFLe_12</a:t>
            </a:r>
            <a:endParaRPr lang="es-ES" i="1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7347" y="3828415"/>
            <a:ext cx="2127542" cy="2127542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9913342" y="3706144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FLe_15</a:t>
            </a:r>
            <a:endParaRPr lang="es-ES" i="1" dirty="0"/>
          </a:p>
        </p:txBody>
      </p:sp>
      <p:sp>
        <p:nvSpPr>
          <p:cNvPr id="10" name="CuadroTexto 9"/>
          <p:cNvSpPr txBox="1"/>
          <p:nvPr/>
        </p:nvSpPr>
        <p:spPr>
          <a:xfrm>
            <a:off x="275186" y="20978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8749059" y="20441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8745854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2214987"/>
              </p:ext>
            </p:extLst>
          </p:nvPr>
        </p:nvGraphicFramePr>
        <p:xfrm>
          <a:off x="8680398" y="5855283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576327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92980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7051917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0964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641" y="1111827"/>
            <a:ext cx="6519949" cy="4889962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302606" y="742495"/>
            <a:ext cx="2756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Im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Width</a:t>
            </a:r>
            <a:r>
              <a:rPr lang="es-ES" i="1" dirty="0" smtClean="0"/>
              <a:t>, </a:t>
            </a:r>
            <a:r>
              <a:rPr lang="es-ES" i="1" dirty="0" err="1" smtClean="0"/>
              <a:t>IFWi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2796" y="868495"/>
            <a:ext cx="5133294" cy="5133294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351818" y="1111827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IFWi_3</a:t>
            </a:r>
            <a:endParaRPr lang="es-ES" i="1" dirty="0"/>
          </a:p>
        </p:txBody>
      </p:sp>
      <p:sp>
        <p:nvSpPr>
          <p:cNvPr id="6" name="CuadroTexto 5"/>
          <p:cNvSpPr txBox="1"/>
          <p:nvPr/>
        </p:nvSpPr>
        <p:spPr>
          <a:xfrm>
            <a:off x="252641" y="40806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7954695" y="37316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7968754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9" name="Tabl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1071362"/>
              </p:ext>
            </p:extLst>
          </p:nvPr>
        </p:nvGraphicFramePr>
        <p:xfrm>
          <a:off x="7910865" y="575669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798635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33318406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r" defTabSz="914400" rtl="0" eaLnBrk="1" fontAlgn="b" latinLnBrk="0" hangingPunct="1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493992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34312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351" y="1049482"/>
            <a:ext cx="7180322" cy="5385242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301267" y="680150"/>
            <a:ext cx="26246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Shape</a:t>
            </a:r>
            <a:r>
              <a:rPr lang="es-ES" i="1" dirty="0" smtClean="0"/>
              <a:t>, </a:t>
            </a:r>
            <a:r>
              <a:rPr lang="es-ES" i="1" dirty="0" err="1" smtClean="0"/>
              <a:t>MFSh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7439" y="29155"/>
            <a:ext cx="1991154" cy="1991154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9128884" y="-75966"/>
            <a:ext cx="9444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Sh_3</a:t>
            </a:r>
            <a:endParaRPr lang="es-ES" i="1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7440" y="3847956"/>
            <a:ext cx="1991154" cy="1991154"/>
          </a:xfrm>
          <a:prstGeom prst="rect">
            <a:avLst/>
          </a:prstGeom>
        </p:spPr>
      </p:pic>
      <p:sp>
        <p:nvSpPr>
          <p:cNvPr id="11" name="CuadroTexto 10"/>
          <p:cNvSpPr txBox="1"/>
          <p:nvPr/>
        </p:nvSpPr>
        <p:spPr>
          <a:xfrm>
            <a:off x="9191402" y="3804309"/>
            <a:ext cx="881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FSh</a:t>
            </a:r>
            <a:r>
              <a:rPr lang="es-ES" i="1" dirty="0" smtClean="0"/>
              <a:t> 5</a:t>
            </a:r>
            <a:endParaRPr lang="es-ES" i="1" dirty="0"/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17439" y="1892700"/>
            <a:ext cx="1991154" cy="1991154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9160143" y="1835643"/>
            <a:ext cx="9444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Sh_4</a:t>
            </a:r>
            <a:endParaRPr lang="es-ES" i="1" dirty="0"/>
          </a:p>
        </p:txBody>
      </p:sp>
      <p:sp>
        <p:nvSpPr>
          <p:cNvPr id="14" name="CuadroTexto 13"/>
          <p:cNvSpPr txBox="1"/>
          <p:nvPr/>
        </p:nvSpPr>
        <p:spPr>
          <a:xfrm>
            <a:off x="280351" y="14360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5" name="CuadroTexto 14"/>
          <p:cNvSpPr txBox="1"/>
          <p:nvPr/>
        </p:nvSpPr>
        <p:spPr>
          <a:xfrm>
            <a:off x="7982405" y="10870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7986413" y="539182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7" name="Tabla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054984"/>
              </p:ext>
            </p:extLst>
          </p:nvPr>
        </p:nvGraphicFramePr>
        <p:xfrm>
          <a:off x="8121154" y="5761161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551254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749946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266936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616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290" y="880630"/>
            <a:ext cx="6251864" cy="4688898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138374" y="511298"/>
            <a:ext cx="2681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Lenght</a:t>
            </a:r>
            <a:r>
              <a:rPr lang="es-ES" i="1" dirty="0" smtClean="0"/>
              <a:t>, </a:t>
            </a:r>
            <a:r>
              <a:rPr lang="es-ES" i="1" dirty="0" err="1" smtClean="0"/>
              <a:t>MFLe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6655" y="350386"/>
            <a:ext cx="2673369" cy="2673369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7966309" y="316320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Le_3</a:t>
            </a:r>
            <a:endParaRPr lang="es-ES" i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0024" y="363761"/>
            <a:ext cx="2659994" cy="2659994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10534724" y="334118"/>
            <a:ext cx="1050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Le_12</a:t>
            </a:r>
            <a:endParaRPr lang="es-ES" i="1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1795" y="3023755"/>
            <a:ext cx="2723087" cy="2723087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6574" y="3053398"/>
            <a:ext cx="2693444" cy="2693444"/>
          </a:xfrm>
          <a:prstGeom prst="rect">
            <a:avLst/>
          </a:prstGeom>
        </p:spPr>
      </p:pic>
      <p:sp>
        <p:nvSpPr>
          <p:cNvPr id="10" name="CuadroTexto 9"/>
          <p:cNvSpPr txBox="1"/>
          <p:nvPr/>
        </p:nvSpPr>
        <p:spPr>
          <a:xfrm>
            <a:off x="7870147" y="298968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Le_6</a:t>
            </a:r>
            <a:endParaRPr lang="es-ES" i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10593234" y="298968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Le_9</a:t>
            </a:r>
            <a:endParaRPr lang="es-ES" i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82142" y="3490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13" name="CuadroTexto 12"/>
          <p:cNvSpPr txBox="1"/>
          <p:nvPr/>
        </p:nvSpPr>
        <p:spPr>
          <a:xfrm>
            <a:off x="7784196" y="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7788204" y="545944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5" name="Tabla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2572055"/>
              </p:ext>
            </p:extLst>
          </p:nvPr>
        </p:nvGraphicFramePr>
        <p:xfrm>
          <a:off x="7941451" y="5829728"/>
          <a:ext cx="3291841" cy="93929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236333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5962817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363662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8769789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3555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862" y="1007918"/>
            <a:ext cx="6636327" cy="497724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2020713" y="638586"/>
            <a:ext cx="2662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err="1" smtClean="0"/>
              <a:t>Mature</a:t>
            </a:r>
            <a:r>
              <a:rPr lang="es-ES" i="1" dirty="0" smtClean="0"/>
              <a:t> </a:t>
            </a:r>
            <a:r>
              <a:rPr lang="es-ES" i="1" dirty="0" err="1" smtClean="0"/>
              <a:t>Fruit</a:t>
            </a:r>
            <a:r>
              <a:rPr lang="es-ES" i="1" dirty="0" smtClean="0"/>
              <a:t> </a:t>
            </a:r>
            <a:r>
              <a:rPr lang="es-ES" i="1" dirty="0" err="1" smtClean="0"/>
              <a:t>Widht</a:t>
            </a:r>
            <a:r>
              <a:rPr lang="es-ES" i="1" dirty="0" smtClean="0"/>
              <a:t>, </a:t>
            </a:r>
            <a:r>
              <a:rPr lang="es-ES" i="1" dirty="0" err="1" smtClean="0"/>
              <a:t>MFWi</a:t>
            </a:r>
            <a:endParaRPr lang="es-ES" i="1" dirty="0"/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2752" y="81025"/>
            <a:ext cx="2936976" cy="2936976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2670" y="2757135"/>
            <a:ext cx="2947058" cy="2947058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8882164" y="45948"/>
            <a:ext cx="978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Wi_3</a:t>
            </a:r>
            <a:endParaRPr lang="es-ES" i="1" dirty="0"/>
          </a:p>
        </p:txBody>
      </p:sp>
      <p:sp>
        <p:nvSpPr>
          <p:cNvPr id="7" name="CuadroTexto 6"/>
          <p:cNvSpPr txBox="1"/>
          <p:nvPr/>
        </p:nvSpPr>
        <p:spPr>
          <a:xfrm>
            <a:off x="8964488" y="2757135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i="1" dirty="0" smtClean="0"/>
              <a:t>MFWi_12</a:t>
            </a:r>
            <a:endParaRPr lang="es-ES" i="1" dirty="0"/>
          </a:p>
        </p:txBody>
      </p:sp>
      <p:sp>
        <p:nvSpPr>
          <p:cNvPr id="8" name="CuadroTexto 7"/>
          <p:cNvSpPr txBox="1"/>
          <p:nvPr/>
        </p:nvSpPr>
        <p:spPr>
          <a:xfrm>
            <a:off x="155862" y="10204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A</a:t>
            </a:r>
            <a:endParaRPr lang="es-ES" b="1" dirty="0"/>
          </a:p>
        </p:txBody>
      </p:sp>
      <p:sp>
        <p:nvSpPr>
          <p:cNvPr id="9" name="CuadroTexto 8"/>
          <p:cNvSpPr txBox="1"/>
          <p:nvPr/>
        </p:nvSpPr>
        <p:spPr>
          <a:xfrm>
            <a:off x="7857916" y="67136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7968754" y="538736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</a:t>
            </a:r>
          </a:p>
        </p:txBody>
      </p:sp>
      <p:graphicFrame>
        <p:nvGraphicFramePr>
          <p:cNvPr id="11" name="Tab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4177587"/>
              </p:ext>
            </p:extLst>
          </p:nvPr>
        </p:nvGraphicFramePr>
        <p:xfrm>
          <a:off x="7910865" y="5756694"/>
          <a:ext cx="3291841" cy="9517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99128"/>
                <a:gridCol w="1392713"/>
              </a:tblGrid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Paip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0316576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4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823957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  <a:tr h="317245">
                <a:tc>
                  <a:txBody>
                    <a:bodyPr/>
                    <a:lstStyle/>
                    <a:p>
                      <a:r>
                        <a:rPr lang="es-ES" sz="1400" dirty="0" smtClean="0"/>
                        <a:t>Paip2015-UPV2015</a:t>
                      </a:r>
                      <a:endParaRPr lang="es-E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4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65413944***</a:t>
                      </a:r>
                      <a:endParaRPr lang="es-ES" sz="14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810" marR="3810" marT="381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1710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841</TotalTime>
  <Words>626</Words>
  <Application>Microsoft Office PowerPoint</Application>
  <PresentationFormat>Panorámica</PresentationFormat>
  <Paragraphs>284</Paragraphs>
  <Slides>23</Slides>
  <Notes>6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3</vt:i4>
      </vt:variant>
    </vt:vector>
  </HeadingPairs>
  <TitlesOfParts>
    <vt:vector size="29" baseType="lpstr">
      <vt:lpstr>Arial</vt:lpstr>
      <vt:lpstr>Calibri</vt:lpstr>
      <vt:lpstr>Calibri Light</vt:lpstr>
      <vt:lpstr>Droid Sans Fallback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eXi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Belen Pico</cp:lastModifiedBy>
  <cp:revision>272</cp:revision>
  <dcterms:created xsi:type="dcterms:W3CDTF">2015-09-25T22:28:02Z</dcterms:created>
  <dcterms:modified xsi:type="dcterms:W3CDTF">2016-12-12T21:02:57Z</dcterms:modified>
</cp:coreProperties>
</file>